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8" r:id="rId13"/>
    <p:sldId id="269" r:id="rId14"/>
    <p:sldId id="270" r:id="rId15"/>
    <p:sldId id="272" r:id="rId16"/>
    <p:sldId id="273" r:id="rId17"/>
    <p:sldId id="274" r:id="rId18"/>
    <p:sldId id="275" r:id="rId19"/>
    <p:sldId id="276" r:id="rId20"/>
    <p:sldId id="277" r:id="rId21"/>
    <p:sldId id="278" r:id="rId22"/>
    <p:sldId id="279" r:id="rId23"/>
    <p:sldId id="280" r:id="rId24"/>
    <p:sldId id="281" r:id="rId25"/>
    <p:sldId id="282" r:id="rId26"/>
    <p:sldId id="283" r:id="rId27"/>
    <p:sldId id="284" r:id="rId28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15"/>
  </p:normalViewPr>
  <p:slideViewPr>
    <p:cSldViewPr snapToGrid="0">
      <p:cViewPr varScale="1">
        <p:scale>
          <a:sx n="114" d="100"/>
          <a:sy n="114" d="100"/>
        </p:scale>
        <p:origin x="4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929504-BAAA-0A8D-7054-5A44EB3708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E68790F-A1D4-27C9-6DF2-65B00C7389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3ABB6585-F9E6-B72E-E505-BCB450C93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C63A521-560C-4F2B-D1A0-3AD88722B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0073B98-E129-D49B-BD89-05DCA2298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41340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ACA3483-0C5A-5575-6C68-6D56CAA5DA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78FECEB6-34DD-DD5C-C8BB-2DF2EDF57D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01E443EE-ADAB-FA2E-64EA-9977120C1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E12A4BC1-1A59-53A5-72F6-B1E70E65A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C960121-63A7-10F7-413A-CD8937C66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11906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8EAC439-5D56-5DEC-D7DD-EC133F64B4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7B13B705-1A92-7925-3E78-19096218A1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80E72C85-B23B-032C-08C7-E00843767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BE6D5629-53DB-2421-5686-BE62543E9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3F04F71-66C0-98F6-3CEB-210C62E27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05644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CEA9AC-4C4E-274A-B79A-2AB21D1DAA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0F2ECD8D-060A-304F-D212-04275431A4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7F2C824-186F-9488-267E-0F50C3028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2B037860-2102-0A12-7375-1E52AC26C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503F6734-4F18-654B-D862-2184EEC8B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60424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E475DF-383D-CA62-BFF0-6A9C70E22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4E5B0D19-8D77-A455-ACAE-F9A09E84C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9C06466-D749-B462-2857-1384A4EE8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B54E45D-4A48-BB1B-15BE-7E0D39BAE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6CE3CEF-A9CB-88FA-823B-AF35222D2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85663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2527E1-CC19-DA07-0825-1DCA54525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5F2FEBB-9ED1-095C-C1D5-6799842512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7F8926F9-55E0-599F-5D47-7B0B1426FE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0FA176DC-831F-8C09-A236-75DBDC17C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A492BF0-598A-A637-F550-5627CF6D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1A5CDFE-35A2-C23A-28FA-48FBEB862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59253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E6BE0E-B1E3-3F33-9E1E-AEB12B4A6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95006392-4DA5-7BFE-7088-91ABFBD25D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3D186AD3-BF05-7E8C-6174-7614D2107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EA31C238-19BF-D781-B0B7-C5C3EBC2CC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B5EFCC30-ECCF-98BE-AC62-B0A5919F06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A6FED1C3-3061-4095-DABA-095DB21DD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491064AF-236B-EABE-DA7D-F650E4CDD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79C68EE5-BA93-B679-6278-2C8E0B456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97210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E0E45A8-DF80-E834-EDA8-BFA5088EA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FD8EC25E-1DAF-2CE3-A3E7-0B56EF703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A17296DD-55A5-4B9E-168A-152A6EB29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1D499C52-43C1-581D-0871-B59BBC7F9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05655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C423C3AD-8ABF-9124-4E74-F6926B01E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DE5E5153-2F98-126A-5B2D-C1DE826C1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C69DDEDA-3B75-09C2-27B6-D7C15A788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89905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5AE8CE-B2C9-F588-6E9B-157B2FD9B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BFDD7264-A8E3-2734-FA9D-2A9EABC9E3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50F68541-C8E5-09CD-C20A-2E134BDFC7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DEB15ED7-75CF-7049-7565-5E0AFAC56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2D0B1F3B-313C-2CF7-86FE-0F0BDA4AD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15D2B5D2-847E-93A4-E1BE-1F8416EBB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810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51F192-D878-837D-242E-3156DDAAD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07FF65B3-EB28-1BFC-1332-2F37BB3172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6C4FE08F-A2C7-F6AC-0BF0-68F2C12CB8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7B58D4A5-15E0-D02A-2C47-02ACE143B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9FD3400-08B4-5F47-7A77-CBA1529D7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BF356CBD-F52B-C131-3AEE-78AE220A4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08425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45BA5C6C-43B4-A056-F4EE-BF47129E6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5EB9A288-B1AB-D862-1952-0C7AF9F075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36D811B7-C7D4-8650-8185-5380E29D38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79565-E337-9146-82D4-3C3F2E3D1D1C}" type="datetimeFigureOut">
              <a:rPr lang="pt-PT" smtClean="0"/>
              <a:t>28/07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6F97E6CC-4B7C-8281-3878-4A61859347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941D982-B946-0B6A-C3DD-5DA26FB96D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58994-4A44-764F-A5C6-7C073014964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47919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9.pn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60;p14">
            <a:extLst>
              <a:ext uri="{FF2B5EF4-FFF2-40B4-BE49-F238E27FC236}">
                <a16:creationId xmlns:a16="http://schemas.microsoft.com/office/drawing/2014/main" id="{B58A942C-764D-7544-12EE-5C35E90DDBD0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339410" y="986119"/>
            <a:ext cx="9513177" cy="5331809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6539589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0</a:t>
            </a:r>
          </a:p>
        </p:txBody>
      </p:sp>
      <p:pic>
        <p:nvPicPr>
          <p:cNvPr id="2" name="Google Shape;105;p21">
            <a:extLst>
              <a:ext uri="{FF2B5EF4-FFF2-40B4-BE49-F238E27FC236}">
                <a16:creationId xmlns:a16="http://schemas.microsoft.com/office/drawing/2014/main" id="{66EEB09B-FBB5-3854-1760-6C52A624FD7A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025690" y="950027"/>
            <a:ext cx="2948325" cy="2731366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oogle Shape;106;p21">
            <a:extLst>
              <a:ext uri="{FF2B5EF4-FFF2-40B4-BE49-F238E27FC236}">
                <a16:creationId xmlns:a16="http://schemas.microsoft.com/office/drawing/2014/main" id="{BC819828-D030-208F-B3AD-C3A8EF803659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217985" y="950037"/>
            <a:ext cx="2948315" cy="2731356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Google Shape;107;p21">
            <a:extLst>
              <a:ext uri="{FF2B5EF4-FFF2-40B4-BE49-F238E27FC236}">
                <a16:creationId xmlns:a16="http://schemas.microsoft.com/office/drawing/2014/main" id="{675A57B5-F403-F4C8-FC73-73A4EC11561F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147685" y="3681393"/>
            <a:ext cx="2948315" cy="273134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oogle Shape;108;p21">
            <a:extLst>
              <a:ext uri="{FF2B5EF4-FFF2-40B4-BE49-F238E27FC236}">
                <a16:creationId xmlns:a16="http://schemas.microsoft.com/office/drawing/2014/main" id="{31704E4D-4D71-987D-907B-B43B45C67327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339970" y="3681393"/>
            <a:ext cx="2948315" cy="273134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527139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1</a:t>
            </a:r>
          </a:p>
        </p:txBody>
      </p:sp>
      <p:pic>
        <p:nvPicPr>
          <p:cNvPr id="4" name="Google Shape;113;p22">
            <a:extLst>
              <a:ext uri="{FF2B5EF4-FFF2-40B4-BE49-F238E27FC236}">
                <a16:creationId xmlns:a16="http://schemas.microsoft.com/office/drawing/2014/main" id="{0B4E1E42-DC4E-59F9-2DEF-686D27F535B6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932789" y="934955"/>
            <a:ext cx="3208527" cy="2898044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114;p22">
            <a:extLst>
              <a:ext uri="{FF2B5EF4-FFF2-40B4-BE49-F238E27FC236}">
                <a16:creationId xmlns:a16="http://schemas.microsoft.com/office/drawing/2014/main" id="{C89A754F-C967-F57C-3416-1FB85A271584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95998" y="934975"/>
            <a:ext cx="3208531" cy="2898024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Google Shape;115;p22">
            <a:extLst>
              <a:ext uri="{FF2B5EF4-FFF2-40B4-BE49-F238E27FC236}">
                <a16:creationId xmlns:a16="http://schemas.microsoft.com/office/drawing/2014/main" id="{7BA298FB-4A39-0713-22C4-94B2B0DECCBA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932785" y="3832999"/>
            <a:ext cx="3208531" cy="2898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Google Shape;116;p22">
            <a:extLst>
              <a:ext uri="{FF2B5EF4-FFF2-40B4-BE49-F238E27FC236}">
                <a16:creationId xmlns:a16="http://schemas.microsoft.com/office/drawing/2014/main" id="{A8B50EB4-71DE-F31F-47F6-DB9BE0849ADF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270005" y="3889622"/>
            <a:ext cx="3208531" cy="289804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687717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2</a:t>
            </a:r>
          </a:p>
        </p:txBody>
      </p:sp>
      <p:pic>
        <p:nvPicPr>
          <p:cNvPr id="2" name="Google Shape;189;p33">
            <a:extLst>
              <a:ext uri="{FF2B5EF4-FFF2-40B4-BE49-F238E27FC236}">
                <a16:creationId xmlns:a16="http://schemas.microsoft.com/office/drawing/2014/main" id="{3BDA9221-6816-1054-D813-4A9FCF30739C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886288" y="1286339"/>
            <a:ext cx="8419420" cy="48387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8317933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3</a:t>
            </a:r>
          </a:p>
        </p:txBody>
      </p:sp>
      <p:pic>
        <p:nvPicPr>
          <p:cNvPr id="3" name="Google Shape;210;p36">
            <a:extLst>
              <a:ext uri="{FF2B5EF4-FFF2-40B4-BE49-F238E27FC236}">
                <a16:creationId xmlns:a16="http://schemas.microsoft.com/office/drawing/2014/main" id="{003C0D31-739D-147C-48F6-DD0A503CA806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435085" y="1325050"/>
            <a:ext cx="7321825" cy="420789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28131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4</a:t>
            </a:r>
          </a:p>
        </p:txBody>
      </p:sp>
      <p:pic>
        <p:nvPicPr>
          <p:cNvPr id="2" name="Google Shape;203;p35">
            <a:extLst>
              <a:ext uri="{FF2B5EF4-FFF2-40B4-BE49-F238E27FC236}">
                <a16:creationId xmlns:a16="http://schemas.microsoft.com/office/drawing/2014/main" id="{6122AC8D-CF9D-C757-6A1B-AB58B1D49AFD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8298006" y="2136961"/>
            <a:ext cx="3375752" cy="3087384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Google Shape;204;p35">
            <a:extLst>
              <a:ext uri="{FF2B5EF4-FFF2-40B4-BE49-F238E27FC236}">
                <a16:creationId xmlns:a16="http://schemas.microsoft.com/office/drawing/2014/main" id="{46EF556D-186C-2FD7-2D34-FC529DED3AD8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485671" y="2120234"/>
            <a:ext cx="3220654" cy="3087384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205;p35">
            <a:extLst>
              <a:ext uri="{FF2B5EF4-FFF2-40B4-BE49-F238E27FC236}">
                <a16:creationId xmlns:a16="http://schemas.microsoft.com/office/drawing/2014/main" id="{7382F667-E2E7-B752-907E-A674794B5C15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518238" y="2120234"/>
            <a:ext cx="3375752" cy="308738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06320235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5</a:t>
            </a:r>
          </a:p>
        </p:txBody>
      </p:sp>
      <p:pic>
        <p:nvPicPr>
          <p:cNvPr id="3" name="Google Shape;283;p47">
            <a:extLst>
              <a:ext uri="{FF2B5EF4-FFF2-40B4-BE49-F238E27FC236}">
                <a16:creationId xmlns:a16="http://schemas.microsoft.com/office/drawing/2014/main" id="{C7F00430-448B-839A-E08F-98FA7949F467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942169" y="1010725"/>
            <a:ext cx="8307658" cy="48365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474048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6</a:t>
            </a:r>
          </a:p>
        </p:txBody>
      </p:sp>
      <p:pic>
        <p:nvPicPr>
          <p:cNvPr id="2" name="Google Shape;277;p46">
            <a:extLst>
              <a:ext uri="{FF2B5EF4-FFF2-40B4-BE49-F238E27FC236}">
                <a16:creationId xmlns:a16="http://schemas.microsoft.com/office/drawing/2014/main" id="{9956C63F-0ECE-C3B1-D1C1-5EFF95711F8D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939798" y="1009800"/>
            <a:ext cx="8312400" cy="48384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190869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7</a:t>
            </a:r>
          </a:p>
        </p:txBody>
      </p:sp>
      <p:pic>
        <p:nvPicPr>
          <p:cNvPr id="3" name="Google Shape;271;p45">
            <a:extLst>
              <a:ext uri="{FF2B5EF4-FFF2-40B4-BE49-F238E27FC236}">
                <a16:creationId xmlns:a16="http://schemas.microsoft.com/office/drawing/2014/main" id="{B2F12818-EE6F-AB91-252D-3C4736B87E28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939798" y="1009800"/>
            <a:ext cx="8312400" cy="48384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7687212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8</a:t>
            </a:r>
          </a:p>
        </p:txBody>
      </p:sp>
      <p:pic>
        <p:nvPicPr>
          <p:cNvPr id="2" name="Google Shape;295;p49">
            <a:extLst>
              <a:ext uri="{FF2B5EF4-FFF2-40B4-BE49-F238E27FC236}">
                <a16:creationId xmlns:a16="http://schemas.microsoft.com/office/drawing/2014/main" id="{3E85032D-7935-2F03-ADAC-6E4C34AA9E84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469615" y="2011787"/>
            <a:ext cx="3522522" cy="28344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Google Shape;297;p49">
            <a:extLst>
              <a:ext uri="{FF2B5EF4-FFF2-40B4-BE49-F238E27FC236}">
                <a16:creationId xmlns:a16="http://schemas.microsoft.com/office/drawing/2014/main" id="{74B16E58-9EA0-7B9F-9188-EB2FB8A789D6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333798" y="2011787"/>
            <a:ext cx="3524400" cy="283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296;p49">
            <a:extLst>
              <a:ext uri="{FF2B5EF4-FFF2-40B4-BE49-F238E27FC236}">
                <a16:creationId xmlns:a16="http://schemas.microsoft.com/office/drawing/2014/main" id="{4F7E967D-4B60-3693-F550-68A42F962EAD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8199859" y="2011787"/>
            <a:ext cx="3524400" cy="28332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90249282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19</a:t>
            </a:r>
          </a:p>
        </p:txBody>
      </p:sp>
      <p:pic>
        <p:nvPicPr>
          <p:cNvPr id="3" name="Google Shape;354;p59">
            <a:extLst>
              <a:ext uri="{FF2B5EF4-FFF2-40B4-BE49-F238E27FC236}">
                <a16:creationId xmlns:a16="http://schemas.microsoft.com/office/drawing/2014/main" id="{7B571ADF-72DA-272D-C72D-9C4FB247722D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423634" y="1135562"/>
            <a:ext cx="7344727" cy="458687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71078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</a:t>
            </a:r>
          </a:p>
        </p:txBody>
      </p:sp>
      <p:pic>
        <p:nvPicPr>
          <p:cNvPr id="2" name="Google Shape;79;p17">
            <a:extLst>
              <a:ext uri="{FF2B5EF4-FFF2-40B4-BE49-F238E27FC236}">
                <a16:creationId xmlns:a16="http://schemas.microsoft.com/office/drawing/2014/main" id="{5ABDF101-93A8-3A3D-A7B8-C156417BF2A3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1339410" y="1065038"/>
            <a:ext cx="9513177" cy="545294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27500551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0</a:t>
            </a:r>
          </a:p>
        </p:txBody>
      </p:sp>
      <p:pic>
        <p:nvPicPr>
          <p:cNvPr id="2" name="Google Shape;359;p60">
            <a:extLst>
              <a:ext uri="{FF2B5EF4-FFF2-40B4-BE49-F238E27FC236}">
                <a16:creationId xmlns:a16="http://schemas.microsoft.com/office/drawing/2014/main" id="{1F7B3C81-7C4D-C587-70F7-A08F10462B17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578586" y="1230613"/>
            <a:ext cx="7034824" cy="439677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5537924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1</a:t>
            </a:r>
          </a:p>
        </p:txBody>
      </p:sp>
      <p:pic>
        <p:nvPicPr>
          <p:cNvPr id="3" name="Google Shape;253;p42">
            <a:extLst>
              <a:ext uri="{FF2B5EF4-FFF2-40B4-BE49-F238E27FC236}">
                <a16:creationId xmlns:a16="http://schemas.microsoft.com/office/drawing/2014/main" id="{53B55107-D194-2880-C937-0507078FF456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380062" y="1313419"/>
            <a:ext cx="5431872" cy="520456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2027637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2</a:t>
            </a:r>
          </a:p>
        </p:txBody>
      </p:sp>
      <p:pic>
        <p:nvPicPr>
          <p:cNvPr id="2" name="Google Shape;177;p31">
            <a:extLst>
              <a:ext uri="{FF2B5EF4-FFF2-40B4-BE49-F238E27FC236}">
                <a16:creationId xmlns:a16="http://schemas.microsoft.com/office/drawing/2014/main" id="{03B2F6D7-050D-78C0-23CA-343B36EC73C3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379798" y="1028721"/>
            <a:ext cx="5432400" cy="5202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1030461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3</a:t>
            </a:r>
          </a:p>
        </p:txBody>
      </p:sp>
      <p:pic>
        <p:nvPicPr>
          <p:cNvPr id="3" name="Google Shape;482;p81">
            <a:extLst>
              <a:ext uri="{FF2B5EF4-FFF2-40B4-BE49-F238E27FC236}">
                <a16:creationId xmlns:a16="http://schemas.microsoft.com/office/drawing/2014/main" id="{2C93E329-B96B-719F-49F8-3102E40D9451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834279" y="1199452"/>
            <a:ext cx="8523437" cy="506126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8801938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4</a:t>
            </a:r>
          </a:p>
        </p:txBody>
      </p:sp>
      <p:pic>
        <p:nvPicPr>
          <p:cNvPr id="2" name="Google Shape;499;p84">
            <a:extLst>
              <a:ext uri="{FF2B5EF4-FFF2-40B4-BE49-F238E27FC236}">
                <a16:creationId xmlns:a16="http://schemas.microsoft.com/office/drawing/2014/main" id="{EE0C264C-6521-C3FD-CF2D-85763B3F0E20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604272" y="1160658"/>
            <a:ext cx="6983452" cy="453668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9372194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5</a:t>
            </a:r>
          </a:p>
        </p:txBody>
      </p:sp>
      <p:pic>
        <p:nvPicPr>
          <p:cNvPr id="3" name="Google Shape;504;p85">
            <a:extLst>
              <a:ext uri="{FF2B5EF4-FFF2-40B4-BE49-F238E27FC236}">
                <a16:creationId xmlns:a16="http://schemas.microsoft.com/office/drawing/2014/main" id="{E35CD9A6-B809-DA3F-22AC-67F51AD22AA0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807063" y="1279107"/>
            <a:ext cx="6577870" cy="429978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4761126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6</a:t>
            </a:r>
          </a:p>
        </p:txBody>
      </p:sp>
      <p:pic>
        <p:nvPicPr>
          <p:cNvPr id="2" name="Google Shape;538;p91">
            <a:extLst>
              <a:ext uri="{FF2B5EF4-FFF2-40B4-BE49-F238E27FC236}">
                <a16:creationId xmlns:a16="http://schemas.microsoft.com/office/drawing/2014/main" id="{AFE8C326-FCD9-0405-C911-4405F2821FD6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602198" y="1161000"/>
            <a:ext cx="6987600" cy="4536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3291930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27</a:t>
            </a:r>
          </a:p>
        </p:txBody>
      </p:sp>
      <p:pic>
        <p:nvPicPr>
          <p:cNvPr id="3" name="Google Shape;545;p92">
            <a:extLst>
              <a:ext uri="{FF2B5EF4-FFF2-40B4-BE49-F238E27FC236}">
                <a16:creationId xmlns:a16="http://schemas.microsoft.com/office/drawing/2014/main" id="{E1BC9119-89DF-8C17-43F4-6DAC1B48B1EC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288384" y="1161000"/>
            <a:ext cx="5615228" cy="4536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389626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3</a:t>
            </a:r>
          </a:p>
        </p:txBody>
      </p:sp>
      <p:pic>
        <p:nvPicPr>
          <p:cNvPr id="3" name="Google Shape;65;p15">
            <a:extLst>
              <a:ext uri="{FF2B5EF4-FFF2-40B4-BE49-F238E27FC236}">
                <a16:creationId xmlns:a16="http://schemas.microsoft.com/office/drawing/2014/main" id="{CD32E047-F314-6D81-5C25-07CF49D06E32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341387" y="1186383"/>
            <a:ext cx="9511200" cy="5331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9290037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4</a:t>
            </a:r>
          </a:p>
        </p:txBody>
      </p:sp>
      <p:pic>
        <p:nvPicPr>
          <p:cNvPr id="2" name="Google Shape;84;p18">
            <a:extLst>
              <a:ext uri="{FF2B5EF4-FFF2-40B4-BE49-F238E27FC236}">
                <a16:creationId xmlns:a16="http://schemas.microsoft.com/office/drawing/2014/main" id="{BA60A556-3E9D-7917-2425-A1F682A07DB7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339410" y="1186383"/>
            <a:ext cx="9511200" cy="5331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4812498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5</a:t>
            </a:r>
          </a:p>
        </p:txBody>
      </p:sp>
      <p:pic>
        <p:nvPicPr>
          <p:cNvPr id="4" name="Google Shape;135;p25">
            <a:extLst>
              <a:ext uri="{FF2B5EF4-FFF2-40B4-BE49-F238E27FC236}">
                <a16:creationId xmlns:a16="http://schemas.microsoft.com/office/drawing/2014/main" id="{8CBA712D-1240-3539-B62D-DBA92EC1E874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118684" y="1172271"/>
            <a:ext cx="3267733" cy="262678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136;p25">
            <a:extLst>
              <a:ext uri="{FF2B5EF4-FFF2-40B4-BE49-F238E27FC236}">
                <a16:creationId xmlns:a16="http://schemas.microsoft.com/office/drawing/2014/main" id="{A4BCD677-4508-7B41-F95C-150135E6C30E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95998" y="1216300"/>
            <a:ext cx="3158170" cy="253872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Google Shape;137;p25">
            <a:extLst>
              <a:ext uri="{FF2B5EF4-FFF2-40B4-BE49-F238E27FC236}">
                <a16:creationId xmlns:a16="http://schemas.microsoft.com/office/drawing/2014/main" id="{4D5AC3EF-B465-8BA9-FECD-A59DA51B5C52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462119" y="4008176"/>
            <a:ext cx="3267758" cy="262679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198017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6</a:t>
            </a:r>
          </a:p>
        </p:txBody>
      </p:sp>
      <p:pic>
        <p:nvPicPr>
          <p:cNvPr id="2" name="Google Shape;142;p26">
            <a:extLst>
              <a:ext uri="{FF2B5EF4-FFF2-40B4-BE49-F238E27FC236}">
                <a16:creationId xmlns:a16="http://schemas.microsoft.com/office/drawing/2014/main" id="{48F7B989-66A1-2607-A84C-9627D19C75EF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294441" y="1315816"/>
            <a:ext cx="2890186" cy="2642811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oogle Shape;143;p26">
            <a:extLst>
              <a:ext uri="{FF2B5EF4-FFF2-40B4-BE49-F238E27FC236}">
                <a16:creationId xmlns:a16="http://schemas.microsoft.com/office/drawing/2014/main" id="{618E79D7-24CA-F03D-4A03-3B0FDC08B602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487990" y="1315816"/>
            <a:ext cx="2890186" cy="2642814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Google Shape;144;p26">
            <a:extLst>
              <a:ext uri="{FF2B5EF4-FFF2-40B4-BE49-F238E27FC236}">
                <a16:creationId xmlns:a16="http://schemas.microsoft.com/office/drawing/2014/main" id="{1DCDB71F-C9E6-83A1-0BB9-55021A8B5C8D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416536" y="4067832"/>
            <a:ext cx="2679462" cy="2450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oogle Shape;145;p26">
            <a:extLst>
              <a:ext uri="{FF2B5EF4-FFF2-40B4-BE49-F238E27FC236}">
                <a16:creationId xmlns:a16="http://schemas.microsoft.com/office/drawing/2014/main" id="{CFDD1D43-293E-DE56-8218-F8D3D6E51E26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487990" y="3958627"/>
            <a:ext cx="2890186" cy="264283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511137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7</a:t>
            </a:r>
          </a:p>
        </p:txBody>
      </p:sp>
      <p:pic>
        <p:nvPicPr>
          <p:cNvPr id="4" name="Google Shape;150;p27">
            <a:extLst>
              <a:ext uri="{FF2B5EF4-FFF2-40B4-BE49-F238E27FC236}">
                <a16:creationId xmlns:a16="http://schemas.microsoft.com/office/drawing/2014/main" id="{33844B07-1576-080C-F52A-37167E836B9A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3182270" y="1066151"/>
            <a:ext cx="2828833" cy="2614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151;p27">
            <a:extLst>
              <a:ext uri="{FF2B5EF4-FFF2-40B4-BE49-F238E27FC236}">
                <a16:creationId xmlns:a16="http://schemas.microsoft.com/office/drawing/2014/main" id="{4AF756F7-44DC-B65C-61FB-E11D9554771C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62260" y="1066157"/>
            <a:ext cx="2828833" cy="261404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Google Shape;152;p27">
            <a:extLst>
              <a:ext uri="{FF2B5EF4-FFF2-40B4-BE49-F238E27FC236}">
                <a16:creationId xmlns:a16="http://schemas.microsoft.com/office/drawing/2014/main" id="{35C056FB-54C5-5F02-79DC-77263607E009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207848" y="3680202"/>
            <a:ext cx="2828833" cy="2614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Google Shape;153;p27">
            <a:extLst>
              <a:ext uri="{FF2B5EF4-FFF2-40B4-BE49-F238E27FC236}">
                <a16:creationId xmlns:a16="http://schemas.microsoft.com/office/drawing/2014/main" id="{5B88FD8B-6305-BA85-5FBF-70A795149E21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155321" y="3680202"/>
            <a:ext cx="2828833" cy="256696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438219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8</a:t>
            </a:r>
          </a:p>
        </p:txBody>
      </p:sp>
      <p:pic>
        <p:nvPicPr>
          <p:cNvPr id="2" name="Google Shape;97;p20">
            <a:extLst>
              <a:ext uri="{FF2B5EF4-FFF2-40B4-BE49-F238E27FC236}">
                <a16:creationId xmlns:a16="http://schemas.microsoft.com/office/drawing/2014/main" id="{FBFE5573-4280-95ED-F16B-FC64A383C5B0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093367" y="1905837"/>
            <a:ext cx="3556692" cy="3046323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oogle Shape;121;p23">
            <a:extLst>
              <a:ext uri="{FF2B5EF4-FFF2-40B4-BE49-F238E27FC236}">
                <a16:creationId xmlns:a16="http://schemas.microsoft.com/office/drawing/2014/main" id="{A88E12C1-F244-DB1A-84F7-27BDE2BDDDE6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95998" y="1496029"/>
            <a:ext cx="5651221" cy="3865941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11">
            <a:extLst>
              <a:ext uri="{FF2B5EF4-FFF2-40B4-BE49-F238E27FC236}">
                <a16:creationId xmlns:a16="http://schemas.microsoft.com/office/drawing/2014/main" id="{C40480F0-A96E-0873-240A-5DDC3194952B}"/>
              </a:ext>
            </a:extLst>
          </p:cNvPr>
          <p:cNvSpPr txBox="1"/>
          <p:nvPr/>
        </p:nvSpPr>
        <p:spPr>
          <a:xfrm>
            <a:off x="1339410" y="1242113"/>
            <a:ext cx="33106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a)</a:t>
            </a:r>
          </a:p>
        </p:txBody>
      </p:sp>
      <p:sp>
        <p:nvSpPr>
          <p:cNvPr id="9" name="TextBox 11">
            <a:extLst>
              <a:ext uri="{FF2B5EF4-FFF2-40B4-BE49-F238E27FC236}">
                <a16:creationId xmlns:a16="http://schemas.microsoft.com/office/drawing/2014/main" id="{E19032C0-CB07-3403-A0B5-F05A08475572}"/>
              </a:ext>
            </a:extLst>
          </p:cNvPr>
          <p:cNvSpPr txBox="1"/>
          <p:nvPr/>
        </p:nvSpPr>
        <p:spPr>
          <a:xfrm>
            <a:off x="7541943" y="1242113"/>
            <a:ext cx="33106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b)</a:t>
            </a:r>
          </a:p>
        </p:txBody>
      </p:sp>
    </p:spTree>
    <p:extLst>
      <p:ext uri="{BB962C8B-B14F-4D97-AF65-F5344CB8AC3E}">
        <p14:creationId xmlns:p14="http://schemas.microsoft.com/office/powerpoint/2010/main" val="17347765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384867CF-957B-ACBF-B98D-E795C125E352}"/>
              </a:ext>
            </a:extLst>
          </p:cNvPr>
          <p:cNvSpPr txBox="1"/>
          <p:nvPr/>
        </p:nvSpPr>
        <p:spPr>
          <a:xfrm>
            <a:off x="1339410" y="340017"/>
            <a:ext cx="9513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2000" b="1" dirty="0">
                <a:latin typeface="Helvetica" pitchFamily="2" charset="0"/>
              </a:rPr>
              <a:t>Supplementary Figure 9</a:t>
            </a:r>
          </a:p>
        </p:txBody>
      </p:sp>
      <p:pic>
        <p:nvPicPr>
          <p:cNvPr id="4" name="Google Shape;98;p20">
            <a:extLst>
              <a:ext uri="{FF2B5EF4-FFF2-40B4-BE49-F238E27FC236}">
                <a16:creationId xmlns:a16="http://schemas.microsoft.com/office/drawing/2014/main" id="{B9E19B8F-7598-3913-2002-392ED46DEE23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520554" y="985239"/>
            <a:ext cx="3185635" cy="2662913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99;p20">
            <a:extLst>
              <a:ext uri="{FF2B5EF4-FFF2-40B4-BE49-F238E27FC236}">
                <a16:creationId xmlns:a16="http://schemas.microsoft.com/office/drawing/2014/main" id="{D2D91693-5BF8-B7E7-8E20-89AF808E2790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95998" y="1063952"/>
            <a:ext cx="2997297" cy="250548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Google Shape;100;p20">
            <a:extLst>
              <a:ext uri="{FF2B5EF4-FFF2-40B4-BE49-F238E27FC236}">
                <a16:creationId xmlns:a16="http://schemas.microsoft.com/office/drawing/2014/main" id="{50CCADFE-C011-C38B-3B6F-65FEB8088BCF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469917" y="3799465"/>
            <a:ext cx="3252162" cy="271851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123276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4</TotalTime>
  <Words>89</Words>
  <Application>Microsoft Macintosh PowerPoint</Application>
  <PresentationFormat>Ecrã Panorâmico</PresentationFormat>
  <Paragraphs>29</Paragraphs>
  <Slides>27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7</vt:i4>
      </vt:variant>
    </vt:vector>
  </HeadingPairs>
  <TitlesOfParts>
    <vt:vector size="32" baseType="lpstr">
      <vt:lpstr>Arial</vt:lpstr>
      <vt:lpstr>Calibri</vt:lpstr>
      <vt:lpstr>Calibri Light</vt:lpstr>
      <vt:lpstr>Helvetica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guel</dc:creator>
  <cp:lastModifiedBy>Miguel Esperança Martins</cp:lastModifiedBy>
  <cp:revision>20</cp:revision>
  <dcterms:created xsi:type="dcterms:W3CDTF">2025-05-16T13:35:05Z</dcterms:created>
  <dcterms:modified xsi:type="dcterms:W3CDTF">2025-07-28T10:59:34Z</dcterms:modified>
</cp:coreProperties>
</file>